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6C2A3-DF11-4799-A946-C4DB546AAF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54771-AF57-4381-B780-7254A71DDA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04AD2-377C-4A3C-A26C-656F74C171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B00DB-DD01-4CF2-9DC3-062F9097D9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95AE7-9DED-41EC-8AA3-4073663820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D44C0-4184-4806-AB0F-449A405317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A5E6E-15E2-4033-BD1A-3AC7F66B8B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077FA-78A5-4CB1-9FCD-6B5BBE577D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08FB6-D12B-4F49-9B98-65DB431768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87B75-D5B4-45E6-BABD-5C06363004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9C635-DA4C-4F1C-8750-09FB50A9BB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DEAC5-DFA8-4750-8443-22D7F23E40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B857C8-8ACA-40AC-89D8-D6EFBB1527C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Supplemental_Figure1_Efm_TX16_Efa_V583_ORF_synteny.png"/>
          <p:cNvPicPr/>
          <p:nvPr/>
        </p:nvPicPr>
        <p:blipFill>
          <a:blip r:embed="rId1"/>
          <a:stretch/>
        </p:blipFill>
        <p:spPr>
          <a:xfrm>
            <a:off x="1447920" y="304920"/>
            <a:ext cx="5715000" cy="571500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>
            <a:off x="380880" y="5867280"/>
            <a:ext cx="8074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- Gene order synteny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faecium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X16 compared 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faecali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58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x and y axis are V583 and TX16 genome coordinates, respectively. The synteny blocks on the positive strand of V583 genome are in red, and the negative strand in green.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8T19:20:21Z</dcterms:created>
  <dc:creator>jgallowaypena</dc:creator>
  <dc:description/>
  <dc:language>en-US</dc:language>
  <cp:lastModifiedBy>jgallowaypena</cp:lastModifiedBy>
  <dcterms:modified xsi:type="dcterms:W3CDTF">2012-05-09T21:04:29Z</dcterms:modified>
  <cp:revision>3</cp:revision>
  <dc:subject/>
  <dc:title>Slide 1</dc:title>
</cp:coreProperties>
</file>